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70" r:id="rId2"/>
  </p:sldIdLst>
  <p:sldSz cx="6254750" cy="8458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 Fig 2" id="{8B478189-5189-4175-BF33-680A6CFBF508}">
          <p14:sldIdLst>
            <p14:sldId id="27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9" clrIdx="0">
    <p:extLst>
      <p:ext uri="{19B8F6BF-5375-455C-9EA6-DF929625EA0E}">
        <p15:presenceInfo xmlns:p15="http://schemas.microsoft.com/office/powerpoint/2012/main" userId="USER" providerId="None"/>
      </p:ext>
    </p:extLst>
  </p:cmAuthor>
  <p:cmAuthor id="2" name="skarimi" initials="s" lastIdx="4" clrIdx="1">
    <p:extLst>
      <p:ext uri="{19B8F6BF-5375-455C-9EA6-DF929625EA0E}">
        <p15:presenceInfo xmlns:p15="http://schemas.microsoft.com/office/powerpoint/2012/main" userId="skarimi" providerId="None"/>
      </p:ext>
    </p:extLst>
  </p:cmAuthor>
  <p:cmAuthor id="3" name="soheila karimi" initials="sk" lastIdx="6" clrIdx="2">
    <p:extLst>
      <p:ext uri="{19B8F6BF-5375-455C-9EA6-DF929625EA0E}">
        <p15:presenceInfo xmlns:p15="http://schemas.microsoft.com/office/powerpoint/2012/main" userId="bb0168d6462bdfd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D222"/>
    <a:srgbClr val="EAB200"/>
    <a:srgbClr val="EA6B14"/>
    <a:srgbClr val="3333FF"/>
    <a:srgbClr val="00FF00"/>
    <a:srgbClr val="1DFF1D"/>
    <a:srgbClr val="000300"/>
    <a:srgbClr val="66A2D8"/>
    <a:srgbClr val="84B4E0"/>
    <a:srgbClr val="5F5FD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26" autoAdjust="0"/>
    <p:restoredTop sz="86861" autoAdjust="0"/>
  </p:normalViewPr>
  <p:slideViewPr>
    <p:cSldViewPr snapToGrid="0">
      <p:cViewPr varScale="1">
        <p:scale>
          <a:sx n="60" d="100"/>
          <a:sy n="60" d="100"/>
        </p:scale>
        <p:origin x="22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3175">
              <a:solidFill>
                <a:schemeClr val="tx1"/>
              </a:solidFill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chemeClr val="tx1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2D8-4957-A3E4-13E4CD9261CF}"/>
              </c:ext>
            </c:extLst>
          </c:dPt>
          <c:dPt>
            <c:idx val="4"/>
            <c:invertIfNegative val="0"/>
            <c:bubble3D val="0"/>
            <c:spPr>
              <a:solidFill>
                <a:srgbClr val="2AD222"/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62D8-4957-A3E4-13E4CD9261CF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2D8-4957-A3E4-13E4CD9261CF}"/>
              </c:ext>
            </c:extLst>
          </c:dPt>
          <c:errBars>
            <c:errBarType val="plus"/>
            <c:errValType val="cust"/>
            <c:noEndCap val="0"/>
            <c:plus>
              <c:numRef>
                <c:f>'Active TNF-a'!$H$11:$H$1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6.903686795797889E-8</c:v>
                  </c:pt>
                  <c:pt idx="4">
                    <c:v>0.10544700004419441</c:v>
                  </c:pt>
                  <c:pt idx="5">
                    <c:v>0.11722207565780648</c:v>
                  </c:pt>
                </c:numCache>
              </c:numRef>
            </c:plus>
            <c:minus>
              <c:numRef>
                <c:f>'Active TNF-a'!$H$11:$H$1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6.903686795797889E-8</c:v>
                  </c:pt>
                  <c:pt idx="4">
                    <c:v>0.10544700004419441</c:v>
                  </c:pt>
                  <c:pt idx="5">
                    <c:v>0.11722207565780648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Active TNF-a'!$B$11:$B$16</c:f>
              <c:strCache>
                <c:ptCount val="6"/>
                <c:pt idx="0">
                  <c:v>M0</c:v>
                </c:pt>
                <c:pt idx="1">
                  <c:v>M0+ Nrg-1 50 ng/ml</c:v>
                </c:pt>
                <c:pt idx="2">
                  <c:v>M0+ Nrg-1 200 ng/ml</c:v>
                </c:pt>
                <c:pt idx="3">
                  <c:v>M1</c:v>
                </c:pt>
                <c:pt idx="4">
                  <c:v>M1+ N50 ng/ml</c:v>
                </c:pt>
                <c:pt idx="5">
                  <c:v>M1+ N200 ng/ml</c:v>
                </c:pt>
              </c:strCache>
            </c:strRef>
          </c:cat>
          <c:val>
            <c:numRef>
              <c:f>'Active TNF-a'!$G$11:$G$16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0000000329910892</c:v>
                </c:pt>
                <c:pt idx="4">
                  <c:v>0.9665239194646128</c:v>
                </c:pt>
                <c:pt idx="5">
                  <c:v>0.757911826452146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D8-4957-A3E4-13E4CD9261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06031071"/>
        <c:axId val="506032735"/>
      </c:barChart>
      <c:catAx>
        <c:axId val="50603107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032735"/>
        <c:crosses val="autoZero"/>
        <c:auto val="1"/>
        <c:lblAlgn val="ctr"/>
        <c:lblOffset val="100"/>
        <c:noMultiLvlLbl val="0"/>
      </c:catAx>
      <c:valAx>
        <c:axId val="50603273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5060310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 w="3175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31C4-41D2-BFD3-FFB1E25D818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31C4-41D2-BFD3-FFB1E25D8184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31C4-41D2-BFD3-FFB1E25D8184}"/>
              </c:ext>
            </c:extLst>
          </c:dPt>
          <c:dPt>
            <c:idx val="3"/>
            <c:invertIfNegative val="0"/>
            <c:bubble3D val="0"/>
            <c:spPr>
              <a:solidFill>
                <a:srgbClr val="2AD222"/>
              </a:solidFill>
              <a:ln w="31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31C4-41D2-BFD3-FFB1E25D8184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W$8:$W$11</c:f>
                <c:numCache>
                  <c:formatCode>General</c:formatCode>
                  <c:ptCount val="4"/>
                  <c:pt idx="0">
                    <c:v>7.046794418815723E-2</c:v>
                  </c:pt>
                  <c:pt idx="1">
                    <c:v>5.8542962620906608E-2</c:v>
                  </c:pt>
                  <c:pt idx="2">
                    <c:v>0.10528048944667638</c:v>
                  </c:pt>
                  <c:pt idx="3">
                    <c:v>0.18787738801408868</c:v>
                  </c:pt>
                </c:numCache>
              </c:numRef>
            </c:plus>
            <c:minus>
              <c:numRef>
                <c:f>Sheet1!$W$8:$W$11</c:f>
                <c:numCache>
                  <c:formatCode>General</c:formatCode>
                  <c:ptCount val="4"/>
                  <c:pt idx="0">
                    <c:v>7.046794418815723E-2</c:v>
                  </c:pt>
                  <c:pt idx="1">
                    <c:v>5.8542962620906608E-2</c:v>
                  </c:pt>
                  <c:pt idx="2">
                    <c:v>0.10528048944667638</c:v>
                  </c:pt>
                  <c:pt idx="3">
                    <c:v>0.18787738801408868</c:v>
                  </c:pt>
                </c:numCache>
              </c:numRef>
            </c:minus>
          </c:errBars>
          <c:cat>
            <c:strRef>
              <c:f>Sheet1!$U$8:$U$11</c:f>
              <c:strCache>
                <c:ptCount val="4"/>
                <c:pt idx="0">
                  <c:v>Control</c:v>
                </c:pt>
                <c:pt idx="1">
                  <c:v>N</c:v>
                </c:pt>
                <c:pt idx="2">
                  <c:v>IT</c:v>
                </c:pt>
                <c:pt idx="3">
                  <c:v>ITN</c:v>
                </c:pt>
              </c:strCache>
            </c:strRef>
          </c:cat>
          <c:val>
            <c:numRef>
              <c:f>Sheet1!$V$8:$V$11</c:f>
              <c:numCache>
                <c:formatCode>General</c:formatCode>
                <c:ptCount val="4"/>
                <c:pt idx="0">
                  <c:v>1.0000000209544706</c:v>
                </c:pt>
                <c:pt idx="1">
                  <c:v>1.2965862057619837</c:v>
                </c:pt>
                <c:pt idx="2">
                  <c:v>0.48541982325574651</c:v>
                </c:pt>
                <c:pt idx="3">
                  <c:v>0.726506648492584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C4-41D2-BFD3-FFB1E25D81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35460736"/>
        <c:axId val="148693760"/>
      </c:barChart>
      <c:catAx>
        <c:axId val="1354607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sz="700">
                <a:noFill/>
              </a:defRPr>
            </a:pPr>
            <a:endParaRPr lang="en-US"/>
          </a:p>
        </c:txPr>
        <c:crossAx val="148693760"/>
        <c:crosses val="autoZero"/>
        <c:auto val="1"/>
        <c:lblAlgn val="ctr"/>
        <c:lblOffset val="100"/>
        <c:noMultiLvlLbl val="0"/>
      </c:catAx>
      <c:valAx>
        <c:axId val="148693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="1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defRPr>
            </a:pPr>
            <a:endParaRPr lang="en-US"/>
          </a:p>
        </c:txPr>
        <c:crossAx val="1354607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80474439886461"/>
          <c:y val="4.640543418923259E-2"/>
          <c:w val="0.89655796150481193"/>
          <c:h val="0.8760265383493729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3175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317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83D-496D-8FB8-79CA1D9DC3E1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317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83D-496D-8FB8-79CA1D9DC3E1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317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83D-496D-8FB8-79CA1D9DC3E1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 w="317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83D-496D-8FB8-79CA1D9DC3E1}"/>
              </c:ext>
            </c:extLst>
          </c:dPt>
          <c:dPt>
            <c:idx val="4"/>
            <c:invertIfNegative val="0"/>
            <c:bubble3D val="0"/>
            <c:spPr>
              <a:solidFill>
                <a:srgbClr val="2AD222"/>
              </a:solidFill>
              <a:ln w="317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83D-496D-8FB8-79CA1D9DC3E1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 w="3175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83D-496D-8FB8-79CA1D9DC3E1}"/>
              </c:ext>
            </c:extLst>
          </c:dPt>
          <c:errBars>
            <c:errBarType val="plus"/>
            <c:errValType val="cust"/>
            <c:noEndCap val="0"/>
            <c:plus>
              <c:numRef>
                <c:f>'Pro-TNF-a'!$I$27:$I$32</c:f>
                <c:numCache>
                  <c:formatCode>General</c:formatCode>
                  <c:ptCount val="6"/>
                  <c:pt idx="0">
                    <c:v>3.3609704824864597E-3</c:v>
                  </c:pt>
                  <c:pt idx="1">
                    <c:v>3.8913601752069292E-3</c:v>
                  </c:pt>
                  <c:pt idx="2">
                    <c:v>5.7424906052707938E-3</c:v>
                  </c:pt>
                  <c:pt idx="3">
                    <c:v>8.6770367162312262E-8</c:v>
                  </c:pt>
                  <c:pt idx="4">
                    <c:v>6.9175309732599527E-2</c:v>
                  </c:pt>
                  <c:pt idx="5">
                    <c:v>0.12734232533468209</c:v>
                  </c:pt>
                </c:numCache>
              </c:numRef>
            </c:plus>
            <c:minus>
              <c:numRef>
                <c:f>'Pro-TNF-a'!$I$27:$I$32</c:f>
                <c:numCache>
                  <c:formatCode>General</c:formatCode>
                  <c:ptCount val="6"/>
                  <c:pt idx="0">
                    <c:v>3.3609704824864597E-3</c:v>
                  </c:pt>
                  <c:pt idx="1">
                    <c:v>3.8913601752069292E-3</c:v>
                  </c:pt>
                  <c:pt idx="2">
                    <c:v>5.7424906052707938E-3</c:v>
                  </c:pt>
                  <c:pt idx="3">
                    <c:v>8.6770367162312262E-8</c:v>
                  </c:pt>
                  <c:pt idx="4">
                    <c:v>6.9175309732599527E-2</c:v>
                  </c:pt>
                  <c:pt idx="5">
                    <c:v>0.12734232533468209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ro-TNF-a'!$C$27:$C$32</c:f>
              <c:strCache>
                <c:ptCount val="6"/>
                <c:pt idx="0">
                  <c:v>M0</c:v>
                </c:pt>
                <c:pt idx="1">
                  <c:v>M0+ Nrg-1 50 ng/ml</c:v>
                </c:pt>
                <c:pt idx="2">
                  <c:v>M0+ Nrg-1 200 ng/ml</c:v>
                </c:pt>
                <c:pt idx="3">
                  <c:v>M1</c:v>
                </c:pt>
                <c:pt idx="4">
                  <c:v>M1+ N50 ng/ml</c:v>
                </c:pt>
                <c:pt idx="5">
                  <c:v>M1+ N200 ng/ml</c:v>
                </c:pt>
              </c:strCache>
            </c:strRef>
          </c:cat>
          <c:val>
            <c:numRef>
              <c:f>'Pro-TNF-a'!$H$27:$H$32</c:f>
              <c:numCache>
                <c:formatCode>General</c:formatCode>
                <c:ptCount val="6"/>
                <c:pt idx="0">
                  <c:v>3.8809144256038877E-3</c:v>
                </c:pt>
                <c:pt idx="1">
                  <c:v>4.49335568933902E-3</c:v>
                </c:pt>
                <c:pt idx="2">
                  <c:v>6.6308569935439798E-3</c:v>
                </c:pt>
                <c:pt idx="3">
                  <c:v>0.99999995127270447</c:v>
                </c:pt>
                <c:pt idx="4">
                  <c:v>0.89932313775611605</c:v>
                </c:pt>
                <c:pt idx="5">
                  <c:v>0.74266754379042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83D-496D-8FB8-79CA1D9DC3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63141279"/>
        <c:axId val="563142111"/>
      </c:barChart>
      <c:catAx>
        <c:axId val="56314127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3142111"/>
        <c:crosses val="autoZero"/>
        <c:auto val="1"/>
        <c:lblAlgn val="ctr"/>
        <c:lblOffset val="100"/>
        <c:noMultiLvlLbl val="0"/>
      </c:catAx>
      <c:valAx>
        <c:axId val="56314211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5631412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817B45-D4D3-45CB-934D-97DF67DE9D2D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7588" y="1143000"/>
            <a:ext cx="22828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61A00-9F51-4288-915B-64876428B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1738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1pPr>
    <a:lvl2pPr marL="36804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2pPr>
    <a:lvl3pPr marL="73609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3pPr>
    <a:lvl4pPr marL="110413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4pPr>
    <a:lvl5pPr marL="1472184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5pPr>
    <a:lvl6pPr marL="1840230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6pPr>
    <a:lvl7pPr marL="2208276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7pPr>
    <a:lvl8pPr marL="2576322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8pPr>
    <a:lvl9pPr marL="2944368" algn="l" defTabSz="736092" rtl="0" eaLnBrk="1" latinLnBrk="0" hangingPunct="1">
      <a:defRPr sz="96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106" y="1384248"/>
            <a:ext cx="5316538" cy="2944707"/>
          </a:xfrm>
        </p:spPr>
        <p:txBody>
          <a:bodyPr anchor="b"/>
          <a:lstStyle>
            <a:lvl1pPr algn="ctr"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1844" y="4442514"/>
            <a:ext cx="4691063" cy="2042106"/>
          </a:xfrm>
        </p:spPr>
        <p:txBody>
          <a:bodyPr/>
          <a:lstStyle>
            <a:lvl1pPr marL="0" indent="0" algn="ctr">
              <a:buNone/>
              <a:defRPr sz="1642"/>
            </a:lvl1pPr>
            <a:lvl2pPr marL="312725" indent="0" algn="ctr">
              <a:buNone/>
              <a:defRPr sz="1368"/>
            </a:lvl2pPr>
            <a:lvl3pPr marL="625450" indent="0" algn="ctr">
              <a:buNone/>
              <a:defRPr sz="1231"/>
            </a:lvl3pPr>
            <a:lvl4pPr marL="938174" indent="0" algn="ctr">
              <a:buNone/>
              <a:defRPr sz="1094"/>
            </a:lvl4pPr>
            <a:lvl5pPr marL="1250899" indent="0" algn="ctr">
              <a:buNone/>
              <a:defRPr sz="1094"/>
            </a:lvl5pPr>
            <a:lvl6pPr marL="1563624" indent="0" algn="ctr">
              <a:buNone/>
              <a:defRPr sz="1094"/>
            </a:lvl6pPr>
            <a:lvl7pPr marL="1876349" indent="0" algn="ctr">
              <a:buNone/>
              <a:defRPr sz="1094"/>
            </a:lvl7pPr>
            <a:lvl8pPr marL="2189074" indent="0" algn="ctr">
              <a:buNone/>
              <a:defRPr sz="1094"/>
            </a:lvl8pPr>
            <a:lvl9pPr marL="2501798" indent="0" algn="ctr">
              <a:buNone/>
              <a:defRPr sz="109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567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255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76056" y="450321"/>
            <a:ext cx="1348680" cy="71679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014" y="450321"/>
            <a:ext cx="3967857" cy="716793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92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468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6757" y="2108679"/>
            <a:ext cx="5394722" cy="3518376"/>
          </a:xfrm>
        </p:spPr>
        <p:txBody>
          <a:bodyPr anchor="b"/>
          <a:lstStyle>
            <a:lvl1pPr>
              <a:defRPr sz="4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6757" y="5660339"/>
            <a:ext cx="5394722" cy="1850231"/>
          </a:xfrm>
        </p:spPr>
        <p:txBody>
          <a:bodyPr/>
          <a:lstStyle>
            <a:lvl1pPr marL="0" indent="0">
              <a:buNone/>
              <a:defRPr sz="1642">
                <a:solidFill>
                  <a:schemeClr val="tx1"/>
                </a:solidFill>
              </a:defRPr>
            </a:lvl1pPr>
            <a:lvl2pPr marL="312725" indent="0">
              <a:buNone/>
              <a:defRPr sz="1368">
                <a:solidFill>
                  <a:schemeClr val="tx1">
                    <a:tint val="75000"/>
                  </a:schemeClr>
                </a:solidFill>
              </a:defRPr>
            </a:lvl2pPr>
            <a:lvl3pPr marL="625450" indent="0">
              <a:buNone/>
              <a:defRPr sz="1231">
                <a:solidFill>
                  <a:schemeClr val="tx1">
                    <a:tint val="75000"/>
                  </a:schemeClr>
                </a:solidFill>
              </a:defRPr>
            </a:lvl3pPr>
            <a:lvl4pPr marL="9381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4pPr>
            <a:lvl5pPr marL="125089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5pPr>
            <a:lvl6pPr marL="156362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6pPr>
            <a:lvl7pPr marL="1876349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7pPr>
            <a:lvl8pPr marL="2189074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8pPr>
            <a:lvl9pPr marL="2501798" indent="0">
              <a:buNone/>
              <a:defRPr sz="109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533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014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66467" y="2251604"/>
            <a:ext cx="2658269" cy="53666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730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450323"/>
            <a:ext cx="5394722" cy="163486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829" y="2073434"/>
            <a:ext cx="2646052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0829" y="3089593"/>
            <a:ext cx="2646052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66468" y="2073434"/>
            <a:ext cx="2659083" cy="1016158"/>
          </a:xfrm>
        </p:spPr>
        <p:txBody>
          <a:bodyPr anchor="b"/>
          <a:lstStyle>
            <a:lvl1pPr marL="0" indent="0">
              <a:buNone/>
              <a:defRPr sz="1642" b="1"/>
            </a:lvl1pPr>
            <a:lvl2pPr marL="312725" indent="0">
              <a:buNone/>
              <a:defRPr sz="1368" b="1"/>
            </a:lvl2pPr>
            <a:lvl3pPr marL="625450" indent="0">
              <a:buNone/>
              <a:defRPr sz="1231" b="1"/>
            </a:lvl3pPr>
            <a:lvl4pPr marL="938174" indent="0">
              <a:buNone/>
              <a:defRPr sz="1094" b="1"/>
            </a:lvl4pPr>
            <a:lvl5pPr marL="1250899" indent="0">
              <a:buNone/>
              <a:defRPr sz="1094" b="1"/>
            </a:lvl5pPr>
            <a:lvl6pPr marL="1563624" indent="0">
              <a:buNone/>
              <a:defRPr sz="1094" b="1"/>
            </a:lvl6pPr>
            <a:lvl7pPr marL="1876349" indent="0">
              <a:buNone/>
              <a:defRPr sz="1094" b="1"/>
            </a:lvl7pPr>
            <a:lvl8pPr marL="2189074" indent="0">
              <a:buNone/>
              <a:defRPr sz="1094" b="1"/>
            </a:lvl8pPr>
            <a:lvl9pPr marL="2501798" indent="0">
              <a:buNone/>
              <a:defRPr sz="109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66468" y="3089593"/>
            <a:ext cx="2659083" cy="454432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17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000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015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59084" y="1217826"/>
            <a:ext cx="3166467" cy="6010804"/>
          </a:xfrm>
        </p:spPr>
        <p:txBody>
          <a:bodyPr/>
          <a:lstStyle>
            <a:lvl1pPr>
              <a:defRPr sz="2189"/>
            </a:lvl1pPr>
            <a:lvl2pPr>
              <a:defRPr sz="1915"/>
            </a:lvl2pPr>
            <a:lvl3pPr>
              <a:defRPr sz="1642"/>
            </a:lvl3pPr>
            <a:lvl4pPr>
              <a:defRPr sz="1368"/>
            </a:lvl4pPr>
            <a:lvl5pPr>
              <a:defRPr sz="1368"/>
            </a:lvl5pPr>
            <a:lvl6pPr>
              <a:defRPr sz="1368"/>
            </a:lvl6pPr>
            <a:lvl7pPr>
              <a:defRPr sz="1368"/>
            </a:lvl7pPr>
            <a:lvl8pPr>
              <a:defRPr sz="1368"/>
            </a:lvl8pPr>
            <a:lvl9pPr>
              <a:defRPr sz="1368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842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829" y="563880"/>
            <a:ext cx="2017320" cy="1973580"/>
          </a:xfrm>
        </p:spPr>
        <p:txBody>
          <a:bodyPr anchor="b"/>
          <a:lstStyle>
            <a:lvl1pPr>
              <a:defRPr sz="21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59084" y="1217826"/>
            <a:ext cx="3166467" cy="6010804"/>
          </a:xfrm>
        </p:spPr>
        <p:txBody>
          <a:bodyPr anchor="t"/>
          <a:lstStyle>
            <a:lvl1pPr marL="0" indent="0">
              <a:buNone/>
              <a:defRPr sz="2189"/>
            </a:lvl1pPr>
            <a:lvl2pPr marL="312725" indent="0">
              <a:buNone/>
              <a:defRPr sz="1915"/>
            </a:lvl2pPr>
            <a:lvl3pPr marL="625450" indent="0">
              <a:buNone/>
              <a:defRPr sz="1642"/>
            </a:lvl3pPr>
            <a:lvl4pPr marL="938174" indent="0">
              <a:buNone/>
              <a:defRPr sz="1368"/>
            </a:lvl4pPr>
            <a:lvl5pPr marL="1250899" indent="0">
              <a:buNone/>
              <a:defRPr sz="1368"/>
            </a:lvl5pPr>
            <a:lvl6pPr marL="1563624" indent="0">
              <a:buNone/>
              <a:defRPr sz="1368"/>
            </a:lvl6pPr>
            <a:lvl7pPr marL="1876349" indent="0">
              <a:buNone/>
              <a:defRPr sz="1368"/>
            </a:lvl7pPr>
            <a:lvl8pPr marL="2189074" indent="0">
              <a:buNone/>
              <a:defRPr sz="1368"/>
            </a:lvl8pPr>
            <a:lvl9pPr marL="2501798" indent="0">
              <a:buNone/>
              <a:defRPr sz="13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0829" y="2537460"/>
            <a:ext cx="2017320" cy="4700959"/>
          </a:xfrm>
        </p:spPr>
        <p:txBody>
          <a:bodyPr/>
          <a:lstStyle>
            <a:lvl1pPr marL="0" indent="0">
              <a:buNone/>
              <a:defRPr sz="1094"/>
            </a:lvl1pPr>
            <a:lvl2pPr marL="312725" indent="0">
              <a:buNone/>
              <a:defRPr sz="958"/>
            </a:lvl2pPr>
            <a:lvl3pPr marL="625450" indent="0">
              <a:buNone/>
              <a:defRPr sz="821"/>
            </a:lvl3pPr>
            <a:lvl4pPr marL="938174" indent="0">
              <a:buNone/>
              <a:defRPr sz="684"/>
            </a:lvl4pPr>
            <a:lvl5pPr marL="1250899" indent="0">
              <a:buNone/>
              <a:defRPr sz="684"/>
            </a:lvl5pPr>
            <a:lvl6pPr marL="1563624" indent="0">
              <a:buNone/>
              <a:defRPr sz="684"/>
            </a:lvl6pPr>
            <a:lvl7pPr marL="1876349" indent="0">
              <a:buNone/>
              <a:defRPr sz="684"/>
            </a:lvl7pPr>
            <a:lvl8pPr marL="2189074" indent="0">
              <a:buNone/>
              <a:defRPr sz="684"/>
            </a:lvl8pPr>
            <a:lvl9pPr marL="2501798" indent="0">
              <a:buNone/>
              <a:defRPr sz="68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3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014" y="450323"/>
            <a:ext cx="5394722" cy="1634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014" y="2251604"/>
            <a:ext cx="5394722" cy="53666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014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583E7-35CE-4CCC-88E2-B853881ACBA0}" type="datetimeFigureOut">
              <a:rPr lang="en-US" smtClean="0"/>
              <a:t>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1886" y="7839500"/>
            <a:ext cx="2110978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17417" y="7839500"/>
            <a:ext cx="1407319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7E058-FEC0-4F0D-986D-6993D11231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93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25450" rtl="0" eaLnBrk="1" latinLnBrk="0" hangingPunct="1">
        <a:lnSpc>
          <a:spcPct val="90000"/>
        </a:lnSpc>
        <a:spcBef>
          <a:spcPct val="0"/>
        </a:spcBef>
        <a:buNone/>
        <a:defRPr sz="30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362" indent="-156362" algn="l" defTabSz="625450" rtl="0" eaLnBrk="1" latinLnBrk="0" hangingPunct="1">
        <a:lnSpc>
          <a:spcPct val="90000"/>
        </a:lnSpc>
        <a:spcBef>
          <a:spcPts val="684"/>
        </a:spcBef>
        <a:buFont typeface="Arial" panose="020B0604020202020204" pitchFamily="34" charset="0"/>
        <a:buChar char="•"/>
        <a:defRPr sz="1915" kern="1200">
          <a:solidFill>
            <a:schemeClr val="tx1"/>
          </a:solidFill>
          <a:latin typeface="+mn-lt"/>
          <a:ea typeface="+mn-ea"/>
          <a:cs typeface="+mn-cs"/>
        </a:defRPr>
      </a:lvl1pPr>
      <a:lvl2pPr marL="46908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642" kern="1200">
          <a:solidFill>
            <a:schemeClr val="tx1"/>
          </a:solidFill>
          <a:latin typeface="+mn-lt"/>
          <a:ea typeface="+mn-ea"/>
          <a:cs typeface="+mn-cs"/>
        </a:defRPr>
      </a:lvl2pPr>
      <a:lvl3pPr marL="78181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368" kern="1200">
          <a:solidFill>
            <a:schemeClr val="tx1"/>
          </a:solidFill>
          <a:latin typeface="+mn-lt"/>
          <a:ea typeface="+mn-ea"/>
          <a:cs typeface="+mn-cs"/>
        </a:defRPr>
      </a:lvl3pPr>
      <a:lvl4pPr marL="1094537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407262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71998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203271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345436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658161" indent="-156362" algn="l" defTabSz="625450" rtl="0" eaLnBrk="1" latinLnBrk="0" hangingPunct="1">
        <a:lnSpc>
          <a:spcPct val="90000"/>
        </a:lnSpc>
        <a:spcBef>
          <a:spcPts val="342"/>
        </a:spcBef>
        <a:buFont typeface="Arial" panose="020B0604020202020204" pitchFamily="34" charset="0"/>
        <a:buChar char="•"/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1pPr>
      <a:lvl2pPr marL="312725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2pPr>
      <a:lvl3pPr marL="625450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3pPr>
      <a:lvl4pPr marL="9381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4pPr>
      <a:lvl5pPr marL="125089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5pPr>
      <a:lvl6pPr marL="156362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6pPr>
      <a:lvl7pPr marL="1876349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7pPr>
      <a:lvl8pPr marL="2189074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8pPr>
      <a:lvl9pPr marL="2501798" algn="l" defTabSz="625450" rtl="0" eaLnBrk="1" latinLnBrk="0" hangingPunct="1">
        <a:defRPr sz="12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chart" Target="../charts/chart2.xml"/><Relationship Id="rId7" Type="http://schemas.openxmlformats.org/officeDocument/2006/relationships/image" Target="../media/image3.e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image" Target="../media/image1.emf"/><Relationship Id="rId10" Type="http://schemas.openxmlformats.org/officeDocument/2006/relationships/image" Target="../media/image6.emf"/><Relationship Id="rId4" Type="http://schemas.openxmlformats.org/officeDocument/2006/relationships/chart" Target="../charts/chart3.xml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409140" y="639273"/>
            <a:ext cx="3590079" cy="667417"/>
            <a:chOff x="567347" y="463438"/>
            <a:chExt cx="3590079" cy="667417"/>
          </a:xfrm>
        </p:grpSpPr>
        <p:sp>
          <p:nvSpPr>
            <p:cNvPr id="25" name="TextBox 91"/>
            <p:cNvSpPr txBox="1"/>
            <p:nvPr/>
          </p:nvSpPr>
          <p:spPr>
            <a:xfrm>
              <a:off x="2601652" y="472303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PM</a:t>
              </a:r>
              <a:endParaRPr lang="en-US" sz="1100" dirty="0"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grpSp>
          <p:nvGrpSpPr>
            <p:cNvPr id="28" name="Group 27"/>
            <p:cNvGrpSpPr/>
            <p:nvPr/>
          </p:nvGrpSpPr>
          <p:grpSpPr>
            <a:xfrm>
              <a:off x="570205" y="463438"/>
              <a:ext cx="1677576" cy="667417"/>
              <a:chOff x="-2051329" y="328864"/>
              <a:chExt cx="1677576" cy="667417"/>
            </a:xfrm>
          </p:grpSpPr>
          <p:sp>
            <p:nvSpPr>
              <p:cNvPr id="36" name="TextBox 88"/>
              <p:cNvSpPr txBox="1"/>
              <p:nvPr/>
            </p:nvSpPr>
            <p:spPr>
              <a:xfrm>
                <a:off x="-1959500" y="328864"/>
                <a:ext cx="53076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solidFill>
                      <a:srgbClr val="000000"/>
                    </a:solidFill>
                    <a:latin typeface="Helvetica" panose="020B0604020202020204" pitchFamily="34" charset="0"/>
                    <a:ea typeface="Times New Roman"/>
                    <a:cs typeface="Helvetica" panose="020B0604020202020204" pitchFamily="34" charset="0"/>
                  </a:rPr>
                  <a:t>  RM</a:t>
                </a:r>
                <a:endParaRPr lang="en-US" sz="1100" dirty="0"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endParaRPr>
              </a:p>
            </p:txBody>
          </p:sp>
          <p:sp>
            <p:nvSpPr>
              <p:cNvPr id="37" name="TextBox 89"/>
              <p:cNvSpPr txBox="1"/>
              <p:nvPr/>
            </p:nvSpPr>
            <p:spPr>
              <a:xfrm>
                <a:off x="-1872860" y="519710"/>
                <a:ext cx="14558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000000"/>
                    </a:solidFill>
                    <a:latin typeface="Helvetica" panose="020B0604020202020204" pitchFamily="34" charset="0"/>
                    <a:ea typeface="Times New Roman"/>
                    <a:cs typeface="Helvetica" panose="020B0604020202020204" pitchFamily="34" charset="0"/>
                  </a:rPr>
                  <a:t>RM+ Nrg-1 50 ng/ml</a:t>
                </a:r>
                <a:endParaRPr lang="en-US" sz="1100" dirty="0"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endParaRPr>
              </a:p>
            </p:txBody>
          </p:sp>
          <p:sp>
            <p:nvSpPr>
              <p:cNvPr id="38" name="TextBox 90"/>
              <p:cNvSpPr txBox="1"/>
              <p:nvPr/>
            </p:nvSpPr>
            <p:spPr>
              <a:xfrm>
                <a:off x="-1869675" y="734671"/>
                <a:ext cx="149592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000000"/>
                    </a:solidFill>
                    <a:latin typeface="Helvetica" panose="020B0604020202020204" pitchFamily="34" charset="0"/>
                    <a:ea typeface="Times New Roman"/>
                    <a:cs typeface="Helvetica" panose="020B0604020202020204" pitchFamily="34" charset="0"/>
                  </a:rPr>
                  <a:t>RM+Nrg-1 200 ng/ml</a:t>
                </a:r>
                <a:endParaRPr lang="en-US" sz="1100" dirty="0"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endParaRP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-2051027" y="600779"/>
                <a:ext cx="203586" cy="126137"/>
              </a:xfrm>
              <a:prstGeom prst="rect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lnSpc>
                    <a:spcPct val="115000"/>
                  </a:lnSpc>
                  <a:spcAft>
                    <a:spcPts val="790"/>
                  </a:spcAft>
                </a:pPr>
                <a:r>
                  <a:rPr lang="en-US" sz="1100" dirty="0">
                    <a:solidFill>
                      <a:schemeClr val="bg1"/>
                    </a:solidFill>
                    <a:latin typeface="Helvetica" panose="020B0604020202020204" pitchFamily="34" charset="0"/>
                    <a:ea typeface="Times New Roman"/>
                    <a:cs typeface="Helvetica" panose="020B0604020202020204" pitchFamily="34" charset="0"/>
                  </a:rPr>
                  <a:t> </a:t>
                </a:r>
                <a:endPara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Calibri"/>
                  <a:cs typeface="Helvetica" panose="020B0604020202020204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-2051329" y="790932"/>
                <a:ext cx="203586" cy="126137"/>
              </a:xfrm>
              <a:prstGeom prst="rect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>
                  <a:lnSpc>
                    <a:spcPct val="115000"/>
                  </a:lnSpc>
                  <a:spcAft>
                    <a:spcPts val="790"/>
                  </a:spcAft>
                </a:pPr>
                <a:r>
                  <a:rPr lang="en-US" sz="1100" dirty="0">
                    <a:solidFill>
                      <a:schemeClr val="bg1"/>
                    </a:solidFill>
                    <a:latin typeface="Helvetica" panose="020B0604020202020204" pitchFamily="34" charset="0"/>
                    <a:ea typeface="Times New Roman"/>
                    <a:cs typeface="Helvetica" panose="020B0604020202020204" pitchFamily="34" charset="0"/>
                  </a:rPr>
                  <a:t> </a:t>
                </a:r>
                <a:endPara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Calibri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9" name="TextBox 93"/>
            <p:cNvSpPr txBox="1"/>
            <p:nvPr/>
          </p:nvSpPr>
          <p:spPr>
            <a:xfrm>
              <a:off x="2584560" y="666821"/>
              <a:ext cx="14943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PM+ Nrg-1 50 ng/ml</a:t>
              </a:r>
              <a:endParaRPr lang="en-US" sz="1100" dirty="0"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sp>
          <p:nvSpPr>
            <p:cNvPr id="30" name="TextBox 96"/>
            <p:cNvSpPr txBox="1"/>
            <p:nvPr/>
          </p:nvSpPr>
          <p:spPr>
            <a:xfrm>
              <a:off x="2584560" y="859695"/>
              <a:ext cx="15728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PM+ Nrg-1 200 ng/ml</a:t>
              </a:r>
              <a:endParaRPr lang="en-US" sz="1100" dirty="0">
                <a:latin typeface="Helvetica" panose="020B0604020202020204" pitchFamily="34" charset="0"/>
                <a:ea typeface="Times New Roman"/>
                <a:cs typeface="Helvetica" panose="020B0604020202020204" pitchFamily="34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2412138" y="536359"/>
              <a:ext cx="203586" cy="126137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10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2409301" y="726331"/>
              <a:ext cx="203586" cy="126137"/>
            </a:xfrm>
            <a:prstGeom prst="rect">
              <a:avLst/>
            </a:prstGeom>
            <a:solidFill>
              <a:srgbClr val="2AD22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10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2408241" y="929792"/>
              <a:ext cx="203586" cy="126137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10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567347" y="527903"/>
              <a:ext cx="203586" cy="126137"/>
            </a:xfrm>
            <a:prstGeom prst="rect">
              <a:avLst/>
            </a:prstGeom>
            <a:solidFill>
              <a:schemeClr val="bg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lnSpc>
                  <a:spcPct val="115000"/>
                </a:lnSpc>
                <a:spcAft>
                  <a:spcPts val="790"/>
                </a:spcAft>
              </a:pPr>
              <a:r>
                <a:rPr lang="en-US" sz="1100" dirty="0">
                  <a:solidFill>
                    <a:schemeClr val="bg1"/>
                  </a:solidFill>
                  <a:latin typeface="Helvetica" panose="020B0604020202020204" pitchFamily="34" charset="0"/>
                  <a:ea typeface="Times New Roman"/>
                  <a:cs typeface="Helvetica" panose="020B0604020202020204" pitchFamily="34" charset="0"/>
                </a:rPr>
                <a:t> </a:t>
              </a:r>
              <a:endParaRPr lang="en-US" sz="1100" dirty="0">
                <a:solidFill>
                  <a:schemeClr val="bg1"/>
                </a:solidFill>
                <a:latin typeface="Helvetica" panose="020B0604020202020204" pitchFamily="34" charset="0"/>
                <a:ea typeface="Calibri"/>
                <a:cs typeface="Helvetica" panose="020B0604020202020204" pitchFamily="34" charset="0"/>
              </a:endParaRPr>
            </a:p>
          </p:txBody>
        </p:sp>
      </p:grpSp>
      <p:sp>
        <p:nvSpPr>
          <p:cNvPr id="52" name="TextBox 107"/>
          <p:cNvSpPr txBox="1"/>
          <p:nvPr/>
        </p:nvSpPr>
        <p:spPr>
          <a:xfrm>
            <a:off x="63004" y="87327"/>
            <a:ext cx="28841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Shahriary et al.- Supplementary Figure 2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3409037" y="1585602"/>
            <a:ext cx="2279986" cy="2346493"/>
            <a:chOff x="3409037" y="1585602"/>
            <a:chExt cx="2279986" cy="2346493"/>
          </a:xfrm>
        </p:grpSpPr>
        <p:sp>
          <p:nvSpPr>
            <p:cNvPr id="21" name="TextBox 20"/>
            <p:cNvSpPr txBox="1"/>
            <p:nvPr/>
          </p:nvSpPr>
          <p:spPr>
            <a:xfrm>
              <a:off x="4092359" y="1984305"/>
              <a:ext cx="137569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Active TNF-</a:t>
              </a:r>
              <a:r>
                <a:rPr lang="el-GR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r>
                <a:rPr lang="en-US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 (72h)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512361" y="1585602"/>
              <a:ext cx="3642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b)</a:t>
              </a:r>
            </a:p>
          </p:txBody>
        </p:sp>
        <p:graphicFrame>
          <p:nvGraphicFramePr>
            <p:cNvPr id="74" name="Chart 7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12136808"/>
                </p:ext>
              </p:extLst>
            </p:nvPr>
          </p:nvGraphicFramePr>
          <p:xfrm>
            <a:off x="3409037" y="2127080"/>
            <a:ext cx="2279986" cy="18050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grpSp>
        <p:nvGrpSpPr>
          <p:cNvPr id="26" name="Group 25"/>
          <p:cNvGrpSpPr/>
          <p:nvPr/>
        </p:nvGrpSpPr>
        <p:grpSpPr>
          <a:xfrm>
            <a:off x="494157" y="4782055"/>
            <a:ext cx="2607926" cy="2553379"/>
            <a:chOff x="494157" y="4782055"/>
            <a:chExt cx="2607926" cy="2553379"/>
          </a:xfrm>
        </p:grpSpPr>
        <p:graphicFrame>
          <p:nvGraphicFramePr>
            <p:cNvPr id="34" name="Chart 3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61255946"/>
                </p:ext>
              </p:extLst>
            </p:nvPr>
          </p:nvGraphicFramePr>
          <p:xfrm>
            <a:off x="957301" y="5308294"/>
            <a:ext cx="2144782" cy="19298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5" name="TextBox 54"/>
            <p:cNvSpPr txBox="1"/>
            <p:nvPr/>
          </p:nvSpPr>
          <p:spPr>
            <a:xfrm rot="16200000">
              <a:off x="-363294" y="5877819"/>
              <a:ext cx="2315066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Fold changes in expression </a:t>
              </a:r>
            </a:p>
            <a:p>
              <a:pPr algn="ctr"/>
              <a:r>
                <a:rPr lang="en-US" sz="1100" b="1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normalized to RM condition</a:t>
              </a:r>
              <a:endParaRPr lang="en-US" sz="11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pPr algn="ctr"/>
              <a:endParaRPr lang="en-US" sz="11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803412" y="5056612"/>
              <a:ext cx="89639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Arg-1 (72h)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41895" y="4782055"/>
              <a:ext cx="35618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c)</a:t>
              </a:r>
            </a:p>
          </p:txBody>
        </p:sp>
        <p:sp>
          <p:nvSpPr>
            <p:cNvPr id="82" name="Left Bracket 81"/>
            <p:cNvSpPr/>
            <p:nvPr/>
          </p:nvSpPr>
          <p:spPr>
            <a:xfrm rot="16200000" flipH="1">
              <a:off x="2105129" y="5416186"/>
              <a:ext cx="61449" cy="38935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0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83" name="Group 82"/>
            <p:cNvGrpSpPr/>
            <p:nvPr/>
          </p:nvGrpSpPr>
          <p:grpSpPr>
            <a:xfrm>
              <a:off x="1940811" y="5388593"/>
              <a:ext cx="943788" cy="277000"/>
              <a:chOff x="1078016" y="1382821"/>
              <a:chExt cx="1453123" cy="206093"/>
            </a:xfrm>
          </p:grpSpPr>
          <p:sp>
            <p:nvSpPr>
              <p:cNvPr id="84" name="TextBox 83"/>
              <p:cNvSpPr txBox="1"/>
              <p:nvPr/>
            </p:nvSpPr>
            <p:spPr>
              <a:xfrm>
                <a:off x="1449785" y="1382821"/>
                <a:ext cx="1081354" cy="206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</a:t>
                </a:r>
              </a:p>
            </p:txBody>
          </p:sp>
          <p:sp>
            <p:nvSpPr>
              <p:cNvPr id="85" name="Left Bracket 84"/>
              <p:cNvSpPr/>
              <p:nvPr/>
            </p:nvSpPr>
            <p:spPr>
              <a:xfrm rot="16200000" flipH="1">
                <a:off x="1692131" y="887611"/>
                <a:ext cx="45719" cy="127395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3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</p:grpSp>
      <p:grpSp>
        <p:nvGrpSpPr>
          <p:cNvPr id="11" name="Group 10"/>
          <p:cNvGrpSpPr/>
          <p:nvPr/>
        </p:nvGrpSpPr>
        <p:grpSpPr>
          <a:xfrm>
            <a:off x="452129" y="1592587"/>
            <a:ext cx="2494916" cy="2455745"/>
            <a:chOff x="452129" y="1592587"/>
            <a:chExt cx="2494916" cy="2455745"/>
          </a:xfrm>
        </p:grpSpPr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97464611"/>
                </p:ext>
              </p:extLst>
            </p:nvPr>
          </p:nvGraphicFramePr>
          <p:xfrm>
            <a:off x="898760" y="2179046"/>
            <a:ext cx="2048285" cy="17530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13" name="Group 12"/>
            <p:cNvGrpSpPr/>
            <p:nvPr/>
          </p:nvGrpSpPr>
          <p:grpSpPr>
            <a:xfrm>
              <a:off x="1388361" y="2203661"/>
              <a:ext cx="794353" cy="277000"/>
              <a:chOff x="1087217" y="1377747"/>
              <a:chExt cx="1273950" cy="206093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1396733" y="1377747"/>
                <a:ext cx="789493" cy="206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**</a:t>
                </a:r>
              </a:p>
            </p:txBody>
          </p:sp>
          <p:sp>
            <p:nvSpPr>
              <p:cNvPr id="17" name="Left Bracket 16"/>
              <p:cNvSpPr/>
              <p:nvPr/>
            </p:nvSpPr>
            <p:spPr>
              <a:xfrm rot="16200000" flipH="1">
                <a:off x="1701332" y="872323"/>
                <a:ext cx="45719" cy="127395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3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 rot="16200000">
              <a:off x="-405322" y="2590717"/>
              <a:ext cx="2315066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Fold changes in expression </a:t>
              </a:r>
            </a:p>
            <a:p>
              <a:pPr algn="ctr"/>
              <a:r>
                <a:rPr lang="en-US" sz="1100" b="1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normalized to PM condition</a:t>
              </a:r>
              <a:endParaRPr lang="en-US" sz="11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pPr algn="ctr"/>
              <a:endParaRPr lang="en-US" sz="11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44626" y="1977523"/>
              <a:ext cx="120257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Pro TNF-</a:t>
              </a:r>
              <a:r>
                <a:rPr lang="el-GR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r>
                <a:rPr lang="en-US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 (72h)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00075" y="1592587"/>
              <a:ext cx="35618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a)</a:t>
              </a:r>
            </a:p>
          </p:txBody>
        </p:sp>
        <p:grpSp>
          <p:nvGrpSpPr>
            <p:cNvPr id="77" name="Group 76"/>
            <p:cNvGrpSpPr/>
            <p:nvPr/>
          </p:nvGrpSpPr>
          <p:grpSpPr>
            <a:xfrm>
              <a:off x="2219683" y="2231449"/>
              <a:ext cx="564164" cy="277000"/>
              <a:chOff x="1087217" y="1393633"/>
              <a:chExt cx="1273950" cy="206093"/>
            </a:xfrm>
          </p:grpSpPr>
          <p:sp>
            <p:nvSpPr>
              <p:cNvPr id="78" name="TextBox 77"/>
              <p:cNvSpPr txBox="1"/>
              <p:nvPr/>
            </p:nvSpPr>
            <p:spPr>
              <a:xfrm>
                <a:off x="1396733" y="1393633"/>
                <a:ext cx="789493" cy="2060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**</a:t>
                </a:r>
              </a:p>
            </p:txBody>
          </p:sp>
          <p:sp>
            <p:nvSpPr>
              <p:cNvPr id="79" name="Left Bracket 78"/>
              <p:cNvSpPr/>
              <p:nvPr/>
            </p:nvSpPr>
            <p:spPr>
              <a:xfrm rot="16200000" flipH="1">
                <a:off x="1701332" y="879967"/>
                <a:ext cx="45719" cy="127395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30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58" name="Left Bracket 57"/>
            <p:cNvSpPr/>
            <p:nvPr/>
          </p:nvSpPr>
          <p:spPr>
            <a:xfrm rot="16200000" flipH="1">
              <a:off x="1877336" y="2135251"/>
              <a:ext cx="48416" cy="56234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0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9" name="Left Bracket 58"/>
            <p:cNvSpPr/>
            <p:nvPr/>
          </p:nvSpPr>
          <p:spPr>
            <a:xfrm rot="16200000" flipH="1">
              <a:off x="2041670" y="2349214"/>
              <a:ext cx="45719" cy="23548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0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491955" y="3800231"/>
            <a:ext cx="2905440" cy="703988"/>
            <a:chOff x="491955" y="3782646"/>
            <a:chExt cx="2905440" cy="703988"/>
          </a:xfrm>
        </p:grpSpPr>
        <p:sp>
          <p:nvSpPr>
            <p:cNvPr id="2" name="TextBox 1"/>
            <p:cNvSpPr txBox="1"/>
            <p:nvPr/>
          </p:nvSpPr>
          <p:spPr>
            <a:xfrm>
              <a:off x="2872892" y="3851896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26kDa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91955" y="4117302"/>
              <a:ext cx="8258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Total protein</a:t>
              </a:r>
            </a:p>
            <a:p>
              <a:pPr algn="ctr"/>
              <a:r>
                <a:rPr lang="en-US" sz="9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Ponceau</a:t>
              </a: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 S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45339" y="3782646"/>
              <a:ext cx="5148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Pro</a:t>
              </a:r>
            </a:p>
            <a:p>
              <a:pPr algn="ctr"/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TNF-</a:t>
              </a:r>
              <a:r>
                <a:rPr lang="el-GR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endParaRPr lang="en-US" sz="9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66034" y="3895168"/>
              <a:ext cx="1689366" cy="170403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266033" y="4138825"/>
              <a:ext cx="1689367" cy="282427"/>
            </a:xfrm>
            <a:prstGeom prst="rect">
              <a:avLst/>
            </a:prstGeom>
          </p:spPr>
        </p:pic>
      </p:grpSp>
      <p:grpSp>
        <p:nvGrpSpPr>
          <p:cNvPr id="18" name="Group 17"/>
          <p:cNvGrpSpPr/>
          <p:nvPr/>
        </p:nvGrpSpPr>
        <p:grpSpPr>
          <a:xfrm>
            <a:off x="3125618" y="3837303"/>
            <a:ext cx="2929557" cy="714175"/>
            <a:chOff x="3125618" y="3784548"/>
            <a:chExt cx="2929557" cy="714175"/>
          </a:xfrm>
        </p:grpSpPr>
        <p:sp>
          <p:nvSpPr>
            <p:cNvPr id="67" name="TextBox 66"/>
            <p:cNvSpPr txBox="1"/>
            <p:nvPr/>
          </p:nvSpPr>
          <p:spPr>
            <a:xfrm>
              <a:off x="5537084" y="3819395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7kDa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391759" y="3784548"/>
              <a:ext cx="5148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Active</a:t>
              </a:r>
            </a:p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TNF-</a:t>
              </a:r>
              <a:r>
                <a:rPr lang="el-GR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α</a:t>
              </a:r>
              <a:endParaRPr lang="en-US" sz="9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125618" y="4129391"/>
              <a:ext cx="8258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Total protein</a:t>
              </a:r>
            </a:p>
            <a:p>
              <a:pPr algn="ctr"/>
              <a:r>
                <a:rPr lang="en-US" sz="9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Ponceau</a:t>
              </a: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 S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59386" y="3852364"/>
              <a:ext cx="1744757" cy="20532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876563" y="4135794"/>
              <a:ext cx="1727580" cy="280748"/>
            </a:xfrm>
            <a:prstGeom prst="rect">
              <a:avLst/>
            </a:prstGeom>
          </p:spPr>
        </p:pic>
      </p:grpSp>
      <p:grpSp>
        <p:nvGrpSpPr>
          <p:cNvPr id="23" name="Group 22"/>
          <p:cNvGrpSpPr/>
          <p:nvPr/>
        </p:nvGrpSpPr>
        <p:grpSpPr>
          <a:xfrm>
            <a:off x="918557" y="7099215"/>
            <a:ext cx="2433090" cy="494148"/>
            <a:chOff x="918557" y="7099215"/>
            <a:chExt cx="2433090" cy="494148"/>
          </a:xfrm>
        </p:grpSpPr>
        <p:sp>
          <p:nvSpPr>
            <p:cNvPr id="68" name="TextBox 67"/>
            <p:cNvSpPr txBox="1"/>
            <p:nvPr/>
          </p:nvSpPr>
          <p:spPr>
            <a:xfrm>
              <a:off x="921567" y="7118151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Arg-1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918557" y="7362531"/>
              <a:ext cx="3863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Actin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2883383" y="7099215"/>
              <a:ext cx="459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40kDa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892269" y="7335434"/>
              <a:ext cx="459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42kDa</a:t>
              </a:r>
            </a:p>
          </p:txBody>
        </p:sp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328006" y="7118151"/>
              <a:ext cx="1619039" cy="17400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328973" y="7357388"/>
              <a:ext cx="1626428" cy="2136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01931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92</TotalTime>
  <Words>92</Words>
  <Application>Microsoft Office PowerPoint</Application>
  <PresentationFormat>Custom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026</cp:revision>
  <cp:lastPrinted>2019-02-02T05:56:56Z</cp:lastPrinted>
  <dcterms:created xsi:type="dcterms:W3CDTF">2018-08-01T14:08:28Z</dcterms:created>
  <dcterms:modified xsi:type="dcterms:W3CDTF">2019-02-14T04:28:16Z</dcterms:modified>
</cp:coreProperties>
</file>